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5.xml.rels" ContentType="application/vnd.openxmlformats-package.relationships+xml"/>
  <Override PartName="/ppt/notesSlides/_rels/notesSlide4.xml.rels" ContentType="application/vnd.openxmlformats-package.relationships+xml"/>
  <Override PartName="/ppt/notesSlides/_rels/notesSlide3.xml.rels" ContentType="application/vnd.openxmlformats-package.relationships+xml"/>
  <Override PartName="/ppt/notesSlides/_rels/notesSlide2.xml.rels" ContentType="application/vnd.openxmlformats-package.relationships+xml"/>
  <Override PartName="/ppt/notesSlides/_rels/notesSlide1.xml.rels" ContentType="application/vnd.openxmlformats-package.relationships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media/image5.png" ContentType="image/png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slide1.xml" ContentType="application/vnd.openxmlformats-officedocument.presentationml.slide+xml"/>
  <Override PartName="/ppt/slides/_rels/slide5.xml.rels" ContentType="application/vnd.openxmlformats-package.relationships+xml"/>
  <Override PartName="/ppt/slides/_rels/slide2.xml.rels" ContentType="application/vnd.openxmlformats-package.relationships+xml"/>
  <Override PartName="/ppt/slides/_rels/slide4.xml.rels" ContentType="application/vnd.openxmlformats-package.relationships+xml"/>
  <Override PartName="/ppt/slides/_rels/slide1.xml.rels" ContentType="application/vnd.openxmlformats-package.relationships+xml"/>
  <Override PartName="/ppt/slides/_rels/slide3.xml.rels" ContentType="application/vnd.openxmlformats-package.relationships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  <p:sldId id="257" r:id="rId5"/>
    <p:sldId id="258" r:id="rId6"/>
    <p:sldId id="259" r:id="rId7"/>
    <p:sldId id="260" r:id="rId8"/>
  </p:sldIdLst>
  <p:sldSz cx="10080625" cy="7559675"/>
  <p:notesSz cx="7772400" cy="100584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slide" Target="slides/slide2.xml"/><Relationship Id="rId6" Type="http://schemas.openxmlformats.org/officeDocument/2006/relationships/slide" Target="slides/slide3.xml"/><Relationship Id="rId7" Type="http://schemas.openxmlformats.org/officeDocument/2006/relationships/slide" Target="slides/slide4.xml"/><Relationship Id="rId8" Type="http://schemas.openxmlformats.org/officeDocument/2006/relationships/slide" Target="slides/slide5.xml"/><Relationship Id="rId9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7772400" cy="10058400"/>
          </a:xfrm>
          <a:prstGeom prst="rect">
            <a:avLst/>
          </a:prstGeom>
          <a:solidFill>
            <a:srgbClr val="ffffff"/>
          </a:solidFill>
          <a:ln w="9360">
            <a:noFill/>
          </a:ln>
        </p:spPr>
        <p:txBody>
          <a:bodyPr lIns="90000" rIns="90000" tIns="45000" bIns="45000" anchor="ctr" anchorCtr="1">
            <a:noAutofit/>
          </a:bodyPr>
          <a:p>
            <a:pPr>
              <a:lnSpc>
                <a:spcPct val="94000"/>
              </a:lnSpc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"/>
          <p:cNvSpPr/>
          <p:nvPr/>
        </p:nvSpPr>
        <p:spPr>
          <a:xfrm>
            <a:off x="0" y="0"/>
            <a:ext cx="7772400" cy="10058400"/>
          </a:xfrm>
          <a:custGeom>
            <a:avLst/>
            <a:gdLst>
              <a:gd name="textAreaLeft" fmla="*/ 360 w 7772400"/>
              <a:gd name="textAreaRight" fmla="*/ 7772040 w 7772400"/>
              <a:gd name="textAreaTop" fmla="*/ 360 h 10058400"/>
              <a:gd name="textAreaBottom" fmla="*/ 10058040 h 10058400"/>
            </a:gdLst>
            <a:ahLst/>
            <a:rect l="textAreaLeft" t="textAreaTop" r="textAreaRight" b="textAreaBottom"/>
            <a:pathLst>
              <a:path w="21600" h="27953">
                <a:moveTo>
                  <a:pt x="4" y="0"/>
                </a:moveTo>
                <a:arcTo wR="4" hR="4" stAng="16200000" swAng="-5400000"/>
                <a:lnTo>
                  <a:pt x="0" y="27949"/>
                </a:lnTo>
                <a:arcTo wR="4" hR="4" stAng="10800000" swAng="-5400000"/>
                <a:lnTo>
                  <a:pt x="21596" y="27953"/>
                </a:lnTo>
                <a:arcTo wR="4" hR="4" stAng="5400000" swAng="-5400000"/>
                <a:lnTo>
                  <a:pt x="21600" y="4"/>
                </a:lnTo>
                <a:arcTo wR="4" hR="4" stAng="0" swAng="-5400000"/>
                <a:close/>
              </a:path>
            </a:pathLst>
          </a:cu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94000"/>
              </a:lnSpc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"/>
          <p:cNvSpPr/>
          <p:nvPr/>
        </p:nvSpPr>
        <p:spPr>
          <a:xfrm>
            <a:off x="0" y="0"/>
            <a:ext cx="7772400" cy="10058400"/>
          </a:xfrm>
          <a:custGeom>
            <a:avLst/>
            <a:gdLst>
              <a:gd name="textAreaLeft" fmla="*/ 360 w 7772400"/>
              <a:gd name="textAreaRight" fmla="*/ 7772040 w 7772400"/>
              <a:gd name="textAreaTop" fmla="*/ 360 h 10058400"/>
              <a:gd name="textAreaBottom" fmla="*/ 10058040 h 10058400"/>
            </a:gdLst>
            <a:ahLst/>
            <a:rect l="textAreaLeft" t="textAreaTop" r="textAreaRight" b="textAreaBottom"/>
            <a:pathLst>
              <a:path w="21600" h="27953">
                <a:moveTo>
                  <a:pt x="4" y="0"/>
                </a:moveTo>
                <a:arcTo wR="4" hR="4" stAng="16200000" swAng="-5400000"/>
                <a:lnTo>
                  <a:pt x="0" y="27949"/>
                </a:lnTo>
                <a:arcTo wR="4" hR="4" stAng="10800000" swAng="-5400000"/>
                <a:lnTo>
                  <a:pt x="21596" y="27953"/>
                </a:lnTo>
                <a:arcTo wR="4" hR="4" stAng="5400000" swAng="-5400000"/>
                <a:lnTo>
                  <a:pt x="21600" y="4"/>
                </a:lnTo>
                <a:arcTo wR="4" hR="4" stAng="0" swAng="-5400000"/>
                <a:close/>
              </a:path>
            </a:pathLst>
          </a:cu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94000"/>
              </a:lnSpc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"/>
          <p:cNvSpPr/>
          <p:nvPr/>
        </p:nvSpPr>
        <p:spPr>
          <a:xfrm>
            <a:off x="0" y="0"/>
            <a:ext cx="7772400" cy="10058400"/>
          </a:xfrm>
          <a:custGeom>
            <a:avLst/>
            <a:gdLst>
              <a:gd name="textAreaLeft" fmla="*/ 360 w 7772400"/>
              <a:gd name="textAreaRight" fmla="*/ 7772040 w 7772400"/>
              <a:gd name="textAreaTop" fmla="*/ 360 h 10058400"/>
              <a:gd name="textAreaBottom" fmla="*/ 10058040 h 10058400"/>
            </a:gdLst>
            <a:ahLst/>
            <a:rect l="textAreaLeft" t="textAreaTop" r="textAreaRight" b="textAreaBottom"/>
            <a:pathLst>
              <a:path w="21600" h="27953">
                <a:moveTo>
                  <a:pt x="4" y="0"/>
                </a:moveTo>
                <a:arcTo wR="4" hR="4" stAng="16200000" swAng="-5400000"/>
                <a:lnTo>
                  <a:pt x="0" y="27949"/>
                </a:lnTo>
                <a:arcTo wR="4" hR="4" stAng="10800000" swAng="-5400000"/>
                <a:lnTo>
                  <a:pt x="21596" y="27953"/>
                </a:lnTo>
                <a:arcTo wR="4" hR="4" stAng="5400000" swAng="-5400000"/>
                <a:lnTo>
                  <a:pt x="21600" y="4"/>
                </a:lnTo>
                <a:arcTo wR="4" hR="4" stAng="0" swAng="-5400000"/>
                <a:close/>
              </a:path>
            </a:pathLst>
          </a:cu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94000"/>
              </a:lnSpc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PlaceHolder 1"/>
          <p:cNvSpPr>
            <a:spLocks noGrp="1"/>
          </p:cNvSpPr>
          <p:nvPr>
            <p:ph type="sldImg"/>
          </p:nvPr>
        </p:nvSpPr>
        <p:spPr>
          <a:xfrm>
            <a:off x="1371600" y="763560"/>
            <a:ext cx="5022720" cy="37656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lnSpc>
                <a:spcPct val="94000"/>
              </a:lnSpc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move the slide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PlaceHolder 2"/>
          <p:cNvSpPr>
            <a:spLocks noGrp="1"/>
          </p:cNvSpPr>
          <p:nvPr>
            <p:ph type="body"/>
          </p:nvPr>
        </p:nvSpPr>
        <p:spPr>
          <a:xfrm>
            <a:off x="777600" y="4776840"/>
            <a:ext cx="6211800" cy="45194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7" name="PlaceHolder 3"/>
          <p:cNvSpPr>
            <a:spLocks noGrp="1"/>
          </p:cNvSpPr>
          <p:nvPr>
            <p:ph type="hdr"/>
          </p:nvPr>
        </p:nvSpPr>
        <p:spPr>
          <a:xfrm>
            <a:off x="-360" y="0"/>
            <a:ext cx="3367080" cy="496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lnSpc>
                <a:spcPct val="93000"/>
              </a:lnSpc>
              <a:buNone/>
              <a:tabLst>
                <a:tab algn="l" pos="0"/>
                <a:tab algn="l" pos="447840"/>
                <a:tab algn="l" pos="896760"/>
                <a:tab algn="l" pos="1346040"/>
                <a:tab algn="l" pos="1795320"/>
                <a:tab algn="l" pos="2244600"/>
                <a:tab algn="l" pos="2693880"/>
                <a:tab algn="l" pos="3143160"/>
                <a:tab algn="l" pos="3592440"/>
                <a:tab algn="l" pos="4041720"/>
                <a:tab algn="l" pos="4491000"/>
                <a:tab algn="l" pos="4940280"/>
                <a:tab algn="l" pos="5389560"/>
                <a:tab algn="l" pos="5838840"/>
                <a:tab algn="l" pos="6288120"/>
                <a:tab algn="l" pos="6737400"/>
                <a:tab algn="l" pos="7186680"/>
                <a:tab algn="l" pos="7635960"/>
                <a:tab algn="l" pos="8085240"/>
                <a:tab algn="l" pos="8534520"/>
                <a:tab algn="l" pos="8983800"/>
                <a:tab algn="l" pos="8985240"/>
                <a:tab algn="l" pos="9434520"/>
                <a:tab algn="l" pos="9883800"/>
                <a:tab algn="l" pos="10333080"/>
                <a:tab algn="l" pos="1078236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Times New Roman"/>
                <a:ea typeface="DejaVu Sans"/>
              </a:rPr>
              <a:t>&lt;head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" name="PlaceHolder 4"/>
          <p:cNvSpPr>
            <a:spLocks noGrp="1"/>
          </p:cNvSpPr>
          <p:nvPr>
            <p:ph type="dt" idx="4"/>
          </p:nvPr>
        </p:nvSpPr>
        <p:spPr>
          <a:xfrm>
            <a:off x="4398480" y="0"/>
            <a:ext cx="3367080" cy="496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lstStyle>
            <a:lvl1pPr indent="0" algn="r">
              <a:lnSpc>
                <a:spcPct val="93000"/>
              </a:lnSpc>
              <a:buNone/>
              <a:tabLst>
                <a:tab algn="l" pos="0"/>
                <a:tab algn="l" pos="447840"/>
                <a:tab algn="l" pos="896760"/>
                <a:tab algn="l" pos="1346040"/>
                <a:tab algn="l" pos="1795320"/>
                <a:tab algn="l" pos="2244600"/>
                <a:tab algn="l" pos="2693880"/>
                <a:tab algn="l" pos="3143160"/>
                <a:tab algn="l" pos="3592440"/>
                <a:tab algn="l" pos="4041720"/>
                <a:tab algn="l" pos="4491000"/>
                <a:tab algn="l" pos="4940280"/>
                <a:tab algn="l" pos="5389560"/>
                <a:tab algn="l" pos="5838840"/>
                <a:tab algn="l" pos="6288120"/>
                <a:tab algn="l" pos="6737400"/>
                <a:tab algn="l" pos="7186680"/>
                <a:tab algn="l" pos="7635960"/>
                <a:tab algn="l" pos="8085240"/>
                <a:tab algn="l" pos="8534520"/>
                <a:tab algn="l" pos="8983800"/>
                <a:tab algn="l" pos="8985240"/>
                <a:tab algn="l" pos="9434520"/>
                <a:tab algn="l" pos="9883800"/>
                <a:tab algn="l" pos="10333080"/>
                <a:tab algn="l" pos="10782360"/>
              </a:tabLst>
              <a:defRPr b="0" lang="en-US" sz="1400" spc="-1" strike="noStrike">
                <a:solidFill>
                  <a:srgbClr val="000000"/>
                </a:solidFill>
                <a:latin typeface="Times New Roman"/>
                <a:ea typeface="DejaVu Sans"/>
              </a:defRPr>
            </a:lvl1pPr>
          </a:lstStyle>
          <a:p>
            <a:pPr indent="0" algn="r">
              <a:lnSpc>
                <a:spcPct val="93000"/>
              </a:lnSpc>
              <a:buNone/>
              <a:tabLst>
                <a:tab algn="l" pos="0"/>
                <a:tab algn="l" pos="447840"/>
                <a:tab algn="l" pos="896760"/>
                <a:tab algn="l" pos="1346040"/>
                <a:tab algn="l" pos="1795320"/>
                <a:tab algn="l" pos="2244600"/>
                <a:tab algn="l" pos="2693880"/>
                <a:tab algn="l" pos="3143160"/>
                <a:tab algn="l" pos="3592440"/>
                <a:tab algn="l" pos="4041720"/>
                <a:tab algn="l" pos="4491000"/>
                <a:tab algn="l" pos="4940280"/>
                <a:tab algn="l" pos="5389560"/>
                <a:tab algn="l" pos="5838840"/>
                <a:tab algn="l" pos="6288120"/>
                <a:tab algn="l" pos="6737400"/>
                <a:tab algn="l" pos="7186680"/>
                <a:tab algn="l" pos="7635960"/>
                <a:tab algn="l" pos="8085240"/>
                <a:tab algn="l" pos="8534520"/>
                <a:tab algn="l" pos="8983800"/>
                <a:tab algn="l" pos="8985240"/>
                <a:tab algn="l" pos="9434520"/>
                <a:tab algn="l" pos="9883800"/>
                <a:tab algn="l" pos="10333080"/>
                <a:tab algn="l" pos="1078236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Times New Roman"/>
                <a:ea typeface="DejaVu Sans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PlaceHolder 5"/>
          <p:cNvSpPr>
            <a:spLocks noGrp="1"/>
          </p:cNvSpPr>
          <p:nvPr>
            <p:ph type="ftr" idx="5"/>
          </p:nvPr>
        </p:nvSpPr>
        <p:spPr>
          <a:xfrm>
            <a:off x="-360" y="9555120"/>
            <a:ext cx="3367080" cy="496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b">
            <a:noAutofit/>
          </a:bodyPr>
          <a:lstStyle>
            <a:lvl1pPr indent="0">
              <a:lnSpc>
                <a:spcPct val="93000"/>
              </a:lnSpc>
              <a:buNone/>
              <a:tabLst>
                <a:tab algn="l" pos="0"/>
                <a:tab algn="l" pos="447840"/>
                <a:tab algn="l" pos="896760"/>
                <a:tab algn="l" pos="1346040"/>
                <a:tab algn="l" pos="1795320"/>
                <a:tab algn="l" pos="2244600"/>
                <a:tab algn="l" pos="2693880"/>
                <a:tab algn="l" pos="3143160"/>
                <a:tab algn="l" pos="3592440"/>
                <a:tab algn="l" pos="4041720"/>
                <a:tab algn="l" pos="4491000"/>
                <a:tab algn="l" pos="4940280"/>
                <a:tab algn="l" pos="5389560"/>
                <a:tab algn="l" pos="5838840"/>
                <a:tab algn="l" pos="6288120"/>
                <a:tab algn="l" pos="6737400"/>
                <a:tab algn="l" pos="7186680"/>
                <a:tab algn="l" pos="7635960"/>
                <a:tab algn="l" pos="8085240"/>
                <a:tab algn="l" pos="8534520"/>
                <a:tab algn="l" pos="8983800"/>
                <a:tab algn="l" pos="8985240"/>
                <a:tab algn="l" pos="9434520"/>
                <a:tab algn="l" pos="9883800"/>
                <a:tab algn="l" pos="10333080"/>
                <a:tab algn="l" pos="10782360"/>
              </a:tabLst>
              <a:defRPr b="0" lang="en-US" sz="1400" spc="-1" strike="noStrike">
                <a:solidFill>
                  <a:srgbClr val="000000"/>
                </a:solidFill>
                <a:latin typeface="Times New Roman"/>
                <a:ea typeface="DejaVu Sans"/>
              </a:defRPr>
            </a:lvl1pPr>
          </a:lstStyle>
          <a:p>
            <a:pPr indent="0">
              <a:lnSpc>
                <a:spcPct val="93000"/>
              </a:lnSpc>
              <a:buNone/>
              <a:tabLst>
                <a:tab algn="l" pos="0"/>
                <a:tab algn="l" pos="447840"/>
                <a:tab algn="l" pos="896760"/>
                <a:tab algn="l" pos="1346040"/>
                <a:tab algn="l" pos="1795320"/>
                <a:tab algn="l" pos="2244600"/>
                <a:tab algn="l" pos="2693880"/>
                <a:tab algn="l" pos="3143160"/>
                <a:tab algn="l" pos="3592440"/>
                <a:tab algn="l" pos="4041720"/>
                <a:tab algn="l" pos="4491000"/>
                <a:tab algn="l" pos="4940280"/>
                <a:tab algn="l" pos="5389560"/>
                <a:tab algn="l" pos="5838840"/>
                <a:tab algn="l" pos="6288120"/>
                <a:tab algn="l" pos="6737400"/>
                <a:tab algn="l" pos="7186680"/>
                <a:tab algn="l" pos="7635960"/>
                <a:tab algn="l" pos="8085240"/>
                <a:tab algn="l" pos="8534520"/>
                <a:tab algn="l" pos="8983800"/>
                <a:tab algn="l" pos="8985240"/>
                <a:tab algn="l" pos="9434520"/>
                <a:tab algn="l" pos="9883800"/>
                <a:tab algn="l" pos="10333080"/>
                <a:tab algn="l" pos="1078236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Times New Roman"/>
                <a:ea typeface="DejaVu Sans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PlaceHolder 6"/>
          <p:cNvSpPr>
            <a:spLocks noGrp="1"/>
          </p:cNvSpPr>
          <p:nvPr>
            <p:ph type="sldNum" idx="6"/>
          </p:nvPr>
        </p:nvSpPr>
        <p:spPr>
          <a:xfrm>
            <a:off x="4398480" y="9555120"/>
            <a:ext cx="3367080" cy="496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b">
            <a:noAutofit/>
          </a:bodyPr>
          <a:lstStyle>
            <a:lvl1pPr indent="0" algn="r">
              <a:lnSpc>
                <a:spcPct val="93000"/>
              </a:lnSpc>
              <a:buNone/>
              <a:tabLst>
                <a:tab algn="l" pos="0"/>
                <a:tab algn="l" pos="447840"/>
                <a:tab algn="l" pos="896760"/>
                <a:tab algn="l" pos="1346040"/>
                <a:tab algn="l" pos="1795320"/>
                <a:tab algn="l" pos="2244600"/>
                <a:tab algn="l" pos="2693880"/>
                <a:tab algn="l" pos="3143160"/>
                <a:tab algn="l" pos="3592440"/>
                <a:tab algn="l" pos="4041720"/>
                <a:tab algn="l" pos="4491000"/>
                <a:tab algn="l" pos="4940280"/>
                <a:tab algn="l" pos="5389560"/>
                <a:tab algn="l" pos="5838840"/>
                <a:tab algn="l" pos="6288120"/>
                <a:tab algn="l" pos="6737400"/>
                <a:tab algn="l" pos="7186680"/>
                <a:tab algn="l" pos="7635960"/>
                <a:tab algn="l" pos="8085240"/>
                <a:tab algn="l" pos="8534520"/>
                <a:tab algn="l" pos="8983800"/>
                <a:tab algn="l" pos="8985240"/>
                <a:tab algn="l" pos="9434520"/>
                <a:tab algn="l" pos="9883800"/>
                <a:tab algn="l" pos="10333080"/>
                <a:tab algn="l" pos="10782360"/>
              </a:tabLst>
              <a:defRPr b="0" lang="en-US" sz="1400" spc="-1" strike="noStrike">
                <a:solidFill>
                  <a:srgbClr val="000000"/>
                </a:solidFill>
                <a:latin typeface="Times New Roman"/>
                <a:ea typeface="DejaVu Sans"/>
              </a:defRPr>
            </a:lvl1pPr>
          </a:lstStyle>
          <a:p>
            <a:pPr indent="0" algn="r">
              <a:lnSpc>
                <a:spcPct val="93000"/>
              </a:lnSpc>
              <a:buNone/>
              <a:tabLst>
                <a:tab algn="l" pos="0"/>
                <a:tab algn="l" pos="447840"/>
                <a:tab algn="l" pos="896760"/>
                <a:tab algn="l" pos="1346040"/>
                <a:tab algn="l" pos="1795320"/>
                <a:tab algn="l" pos="2244600"/>
                <a:tab algn="l" pos="2693880"/>
                <a:tab algn="l" pos="3143160"/>
                <a:tab algn="l" pos="3592440"/>
                <a:tab algn="l" pos="4041720"/>
                <a:tab algn="l" pos="4491000"/>
                <a:tab algn="l" pos="4940280"/>
                <a:tab algn="l" pos="5389560"/>
                <a:tab algn="l" pos="5838840"/>
                <a:tab algn="l" pos="6288120"/>
                <a:tab algn="l" pos="6737400"/>
                <a:tab algn="l" pos="7186680"/>
                <a:tab algn="l" pos="7635960"/>
                <a:tab algn="l" pos="8085240"/>
                <a:tab algn="l" pos="8534520"/>
                <a:tab algn="l" pos="8983800"/>
                <a:tab algn="l" pos="8985240"/>
                <a:tab algn="l" pos="9434520"/>
                <a:tab algn="l" pos="9883800"/>
                <a:tab algn="l" pos="10333080"/>
                <a:tab algn="l" pos="10782360"/>
              </a:tabLst>
            </a:pPr>
            <a:fld id="{F760E5A0-DE36-4CE8-B851-A90408C9CE7E}" type="slidenum">
              <a:rPr b="0" lang="en-US" sz="1400" spc="-1" strike="noStrike">
                <a:solidFill>
                  <a:srgbClr val="000000"/>
                </a:solidFill>
                <a:latin typeface="Times New Roman"/>
                <a:ea typeface="DejaVu Sans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.xml.rels><?xml version="1.0" encoding="UTF-8"?>
<Relationships xmlns="http://schemas.openxmlformats.org/package/2006/relationships"><Relationship Id="rId1" Type="http://schemas.openxmlformats.org/officeDocument/2006/relationships/slide" Target="../slides/slide1.xml"/><Relationship Id="rId2" Type="http://schemas.openxmlformats.org/officeDocument/2006/relationships/notesMaster" Target="../notesMasters/notesMaster1.xml"/>
</Relationships>
</file>

<file path=ppt/notesSlides/_rels/notesSlide2.xml.rels><?xml version="1.0" encoding="UTF-8"?>
<Relationships xmlns="http://schemas.openxmlformats.org/package/2006/relationships"><Relationship Id="rId1" Type="http://schemas.openxmlformats.org/officeDocument/2006/relationships/slide" Target="../slides/slide2.xml"/><Relationship Id="rId2" Type="http://schemas.openxmlformats.org/officeDocument/2006/relationships/notesMaster" Target="../notesMasters/notesMaster1.xml"/>
</Relationships>
</file>

<file path=ppt/notesSlides/_rels/notesSlide3.xml.rels><?xml version="1.0" encoding="UTF-8"?>
<Relationships xmlns="http://schemas.openxmlformats.org/package/2006/relationships"><Relationship Id="rId1" Type="http://schemas.openxmlformats.org/officeDocument/2006/relationships/slide" Target="../slides/slide3.xml"/><Relationship Id="rId2" Type="http://schemas.openxmlformats.org/officeDocument/2006/relationships/notesMaster" Target="../notesMasters/notesMaster1.xml"/>
</Relationships>
</file>

<file path=ppt/notesSlides/_rels/notesSlide4.xml.rels><?xml version="1.0" encoding="UTF-8"?>
<Relationships xmlns="http://schemas.openxmlformats.org/package/2006/relationships"><Relationship Id="rId1" Type="http://schemas.openxmlformats.org/officeDocument/2006/relationships/slide" Target="../slides/slide4.xml"/><Relationship Id="rId2" Type="http://schemas.openxmlformats.org/officeDocument/2006/relationships/notesMaster" Target="../notesMasters/notesMaster1.xml"/>
</Relationships>
</file>

<file path=ppt/notesSlides/_rels/notesSlide5.xml.rels><?xml version="1.0" encoding="UTF-8"?>
<Relationships xmlns="http://schemas.openxmlformats.org/package/2006/relationships"><Relationship Id="rId1" Type="http://schemas.openxmlformats.org/officeDocument/2006/relationships/slide" Target="../slides/slide5.xml"/>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5" name="PlaceHolder 1"/>
          <p:cNvSpPr>
            <a:spLocks noGrp="1"/>
          </p:cNvSpPr>
          <p:nvPr>
            <p:ph type="sldImg"/>
          </p:nvPr>
        </p:nvSpPr>
        <p:spPr>
          <a:xfrm>
            <a:off x="1371600" y="763560"/>
            <a:ext cx="5029200" cy="3772080"/>
          </a:xfrm>
          <a:prstGeom prst="rect">
            <a:avLst/>
          </a:prstGeom>
          <a:ln w="0">
            <a:noFill/>
          </a:ln>
        </p:spPr>
      </p:sp>
      <p:sp>
        <p:nvSpPr>
          <p:cNvPr id="86" name=""/>
          <p:cNvSpPr/>
          <p:nvPr/>
        </p:nvSpPr>
        <p:spPr>
          <a:xfrm>
            <a:off x="777960" y="4776840"/>
            <a:ext cx="6218280" cy="4525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94000"/>
              </a:lnSpc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notesSlides/notesSlide2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7" name="PlaceHolder 1"/>
          <p:cNvSpPr>
            <a:spLocks noGrp="1"/>
          </p:cNvSpPr>
          <p:nvPr>
            <p:ph type="sldImg"/>
          </p:nvPr>
        </p:nvSpPr>
        <p:spPr>
          <a:xfrm>
            <a:off x="1371600" y="763560"/>
            <a:ext cx="5029200" cy="3772080"/>
          </a:xfrm>
          <a:prstGeom prst="rect">
            <a:avLst/>
          </a:prstGeom>
          <a:ln w="0">
            <a:noFill/>
          </a:ln>
        </p:spPr>
      </p:sp>
      <p:sp>
        <p:nvSpPr>
          <p:cNvPr id="88" name=""/>
          <p:cNvSpPr/>
          <p:nvPr/>
        </p:nvSpPr>
        <p:spPr>
          <a:xfrm>
            <a:off x="777960" y="4776840"/>
            <a:ext cx="6218280" cy="4525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94000"/>
              </a:lnSpc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notesSlides/notesSlide3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9" name="PlaceHolder 1"/>
          <p:cNvSpPr>
            <a:spLocks noGrp="1"/>
          </p:cNvSpPr>
          <p:nvPr>
            <p:ph type="sldImg"/>
          </p:nvPr>
        </p:nvSpPr>
        <p:spPr>
          <a:xfrm>
            <a:off x="1371600" y="763560"/>
            <a:ext cx="5029200" cy="3772080"/>
          </a:xfrm>
          <a:prstGeom prst="rect">
            <a:avLst/>
          </a:prstGeom>
          <a:ln w="0">
            <a:noFill/>
          </a:ln>
        </p:spPr>
      </p:sp>
      <p:sp>
        <p:nvSpPr>
          <p:cNvPr id="90" name=""/>
          <p:cNvSpPr/>
          <p:nvPr/>
        </p:nvSpPr>
        <p:spPr>
          <a:xfrm>
            <a:off x="777960" y="4776840"/>
            <a:ext cx="6218280" cy="4525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94000"/>
              </a:lnSpc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notesSlides/notesSlide4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1" name="PlaceHolder 1"/>
          <p:cNvSpPr>
            <a:spLocks noGrp="1"/>
          </p:cNvSpPr>
          <p:nvPr>
            <p:ph type="sldImg"/>
          </p:nvPr>
        </p:nvSpPr>
        <p:spPr>
          <a:xfrm>
            <a:off x="1371600" y="763560"/>
            <a:ext cx="5029200" cy="3772080"/>
          </a:xfrm>
          <a:prstGeom prst="rect">
            <a:avLst/>
          </a:prstGeom>
          <a:ln w="0">
            <a:noFill/>
          </a:ln>
        </p:spPr>
      </p:sp>
      <p:sp>
        <p:nvSpPr>
          <p:cNvPr id="92" name=""/>
          <p:cNvSpPr/>
          <p:nvPr/>
        </p:nvSpPr>
        <p:spPr>
          <a:xfrm>
            <a:off x="777960" y="4776840"/>
            <a:ext cx="6218280" cy="4525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94000"/>
              </a:lnSpc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notesSlides/notesSlide5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3" name="PlaceHolder 1"/>
          <p:cNvSpPr>
            <a:spLocks noGrp="1"/>
          </p:cNvSpPr>
          <p:nvPr>
            <p:ph type="sldImg"/>
          </p:nvPr>
        </p:nvSpPr>
        <p:spPr>
          <a:xfrm>
            <a:off x="1371600" y="763560"/>
            <a:ext cx="5029200" cy="3772080"/>
          </a:xfrm>
          <a:prstGeom prst="rect">
            <a:avLst/>
          </a:prstGeom>
          <a:ln w="0">
            <a:noFill/>
          </a:ln>
        </p:spPr>
      </p:sp>
      <p:sp>
        <p:nvSpPr>
          <p:cNvPr id="94" name=""/>
          <p:cNvSpPr/>
          <p:nvPr/>
        </p:nvSpPr>
        <p:spPr>
          <a:xfrm>
            <a:off x="777960" y="4776840"/>
            <a:ext cx="6218280" cy="4525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94000"/>
              </a:lnSpc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763845B-8C2F-4F41-9902-0A08CAC0E5AB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502920" y="301680"/>
            <a:ext cx="9064440" cy="12556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4000"/>
              </a:lnSpc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502920" y="1768320"/>
            <a:ext cx="9064440" cy="2088360"/>
          </a:xfrm>
          <a:prstGeom prst="rect">
            <a:avLst/>
          </a:prstGeom>
          <a:noFill/>
          <a:ln w="0">
            <a:noFill/>
          </a:ln>
        </p:spPr>
        <p:txBody>
          <a:bodyPr lIns="0" rIns="0" tIns="24120" bIns="0" anchor="t">
            <a:normAutofit/>
          </a:bodyPr>
          <a:p>
            <a:pPr marL="343080" indent="0">
              <a:lnSpc>
                <a:spcPct val="94000"/>
              </a:lnSpc>
              <a:spcAft>
                <a:spcPts val="1426"/>
              </a:spcAft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502920" y="4055400"/>
            <a:ext cx="9064440" cy="2088360"/>
          </a:xfrm>
          <a:prstGeom prst="rect">
            <a:avLst/>
          </a:prstGeom>
          <a:noFill/>
          <a:ln w="0">
            <a:noFill/>
          </a:ln>
        </p:spPr>
        <p:txBody>
          <a:bodyPr lIns="0" rIns="0" tIns="24120" bIns="0" anchor="t">
            <a:normAutofit/>
          </a:bodyPr>
          <a:p>
            <a:pPr marL="343080" indent="0">
              <a:lnSpc>
                <a:spcPct val="94000"/>
              </a:lnSpc>
              <a:spcAft>
                <a:spcPts val="1426"/>
              </a:spcAft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188470D-61DA-4BA1-973C-748CEE6D833D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502920" y="301680"/>
            <a:ext cx="9064440" cy="12556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4000"/>
              </a:lnSpc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502920" y="1768320"/>
            <a:ext cx="4423320" cy="2088360"/>
          </a:xfrm>
          <a:prstGeom prst="rect">
            <a:avLst/>
          </a:prstGeom>
          <a:noFill/>
          <a:ln w="0">
            <a:noFill/>
          </a:ln>
        </p:spPr>
        <p:txBody>
          <a:bodyPr lIns="0" rIns="0" tIns="24120" bIns="0" anchor="t">
            <a:normAutofit/>
          </a:bodyPr>
          <a:p>
            <a:pPr marL="343080" indent="0">
              <a:lnSpc>
                <a:spcPct val="94000"/>
              </a:lnSpc>
              <a:spcAft>
                <a:spcPts val="1426"/>
              </a:spcAft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5147640" y="1768320"/>
            <a:ext cx="4423320" cy="2088360"/>
          </a:xfrm>
          <a:prstGeom prst="rect">
            <a:avLst/>
          </a:prstGeom>
          <a:noFill/>
          <a:ln w="0">
            <a:noFill/>
          </a:ln>
        </p:spPr>
        <p:txBody>
          <a:bodyPr lIns="0" rIns="0" tIns="24120" bIns="0" anchor="t">
            <a:normAutofit/>
          </a:bodyPr>
          <a:p>
            <a:pPr marL="343080" indent="0">
              <a:lnSpc>
                <a:spcPct val="94000"/>
              </a:lnSpc>
              <a:spcAft>
                <a:spcPts val="1426"/>
              </a:spcAft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502920" y="4055400"/>
            <a:ext cx="4423320" cy="2088360"/>
          </a:xfrm>
          <a:prstGeom prst="rect">
            <a:avLst/>
          </a:prstGeom>
          <a:noFill/>
          <a:ln w="0">
            <a:noFill/>
          </a:ln>
        </p:spPr>
        <p:txBody>
          <a:bodyPr lIns="0" rIns="0" tIns="24120" bIns="0" anchor="t">
            <a:normAutofit/>
          </a:bodyPr>
          <a:p>
            <a:pPr marL="343080" indent="0">
              <a:lnSpc>
                <a:spcPct val="94000"/>
              </a:lnSpc>
              <a:spcAft>
                <a:spcPts val="1426"/>
              </a:spcAft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5147640" y="4055400"/>
            <a:ext cx="4423320" cy="2088360"/>
          </a:xfrm>
          <a:prstGeom prst="rect">
            <a:avLst/>
          </a:prstGeom>
          <a:noFill/>
          <a:ln w="0">
            <a:noFill/>
          </a:ln>
        </p:spPr>
        <p:txBody>
          <a:bodyPr lIns="0" rIns="0" tIns="24120" bIns="0" anchor="t">
            <a:normAutofit/>
          </a:bodyPr>
          <a:p>
            <a:pPr marL="343080" indent="0">
              <a:lnSpc>
                <a:spcPct val="94000"/>
              </a:lnSpc>
              <a:spcAft>
                <a:spcPts val="1426"/>
              </a:spcAft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97BDFF3-51E8-4A62-86CE-D362C8D8C48D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502920" y="301680"/>
            <a:ext cx="9064440" cy="12556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4000"/>
              </a:lnSpc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502920" y="1768320"/>
            <a:ext cx="2918520" cy="2088360"/>
          </a:xfrm>
          <a:prstGeom prst="rect">
            <a:avLst/>
          </a:prstGeom>
          <a:noFill/>
          <a:ln w="0">
            <a:noFill/>
          </a:ln>
        </p:spPr>
        <p:txBody>
          <a:bodyPr lIns="0" rIns="0" tIns="24120" bIns="0" anchor="t">
            <a:normAutofit/>
          </a:bodyPr>
          <a:p>
            <a:pPr marL="343080" indent="0">
              <a:lnSpc>
                <a:spcPct val="94000"/>
              </a:lnSpc>
              <a:spcAft>
                <a:spcPts val="1426"/>
              </a:spcAft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567600" y="1768320"/>
            <a:ext cx="2918520" cy="2088360"/>
          </a:xfrm>
          <a:prstGeom prst="rect">
            <a:avLst/>
          </a:prstGeom>
          <a:noFill/>
          <a:ln w="0">
            <a:noFill/>
          </a:ln>
        </p:spPr>
        <p:txBody>
          <a:bodyPr lIns="0" rIns="0" tIns="24120" bIns="0" anchor="t">
            <a:normAutofit/>
          </a:bodyPr>
          <a:p>
            <a:pPr marL="343080" indent="0">
              <a:lnSpc>
                <a:spcPct val="94000"/>
              </a:lnSpc>
              <a:spcAft>
                <a:spcPts val="1426"/>
              </a:spcAft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632640" y="1768320"/>
            <a:ext cx="2918520" cy="2088360"/>
          </a:xfrm>
          <a:prstGeom prst="rect">
            <a:avLst/>
          </a:prstGeom>
          <a:noFill/>
          <a:ln w="0">
            <a:noFill/>
          </a:ln>
        </p:spPr>
        <p:txBody>
          <a:bodyPr lIns="0" rIns="0" tIns="24120" bIns="0" anchor="t">
            <a:normAutofit/>
          </a:bodyPr>
          <a:p>
            <a:pPr marL="343080" indent="0">
              <a:lnSpc>
                <a:spcPct val="94000"/>
              </a:lnSpc>
              <a:spcAft>
                <a:spcPts val="1426"/>
              </a:spcAft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502920" y="4055400"/>
            <a:ext cx="2918520" cy="2088360"/>
          </a:xfrm>
          <a:prstGeom prst="rect">
            <a:avLst/>
          </a:prstGeom>
          <a:noFill/>
          <a:ln w="0">
            <a:noFill/>
          </a:ln>
        </p:spPr>
        <p:txBody>
          <a:bodyPr lIns="0" rIns="0" tIns="24120" bIns="0" anchor="t">
            <a:normAutofit/>
          </a:bodyPr>
          <a:p>
            <a:pPr marL="343080" indent="0">
              <a:lnSpc>
                <a:spcPct val="94000"/>
              </a:lnSpc>
              <a:spcAft>
                <a:spcPts val="1426"/>
              </a:spcAft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567600" y="4055400"/>
            <a:ext cx="2918520" cy="2088360"/>
          </a:xfrm>
          <a:prstGeom prst="rect">
            <a:avLst/>
          </a:prstGeom>
          <a:noFill/>
          <a:ln w="0">
            <a:noFill/>
          </a:ln>
        </p:spPr>
        <p:txBody>
          <a:bodyPr lIns="0" rIns="0" tIns="24120" bIns="0" anchor="t">
            <a:normAutofit/>
          </a:bodyPr>
          <a:p>
            <a:pPr marL="343080" indent="0">
              <a:lnSpc>
                <a:spcPct val="94000"/>
              </a:lnSpc>
              <a:spcAft>
                <a:spcPts val="1426"/>
              </a:spcAft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632640" y="4055400"/>
            <a:ext cx="2918520" cy="2088360"/>
          </a:xfrm>
          <a:prstGeom prst="rect">
            <a:avLst/>
          </a:prstGeom>
          <a:noFill/>
          <a:ln w="0">
            <a:noFill/>
          </a:ln>
        </p:spPr>
        <p:txBody>
          <a:bodyPr lIns="0" rIns="0" tIns="24120" bIns="0" anchor="t">
            <a:normAutofit/>
          </a:bodyPr>
          <a:p>
            <a:pPr marL="343080" indent="0">
              <a:lnSpc>
                <a:spcPct val="94000"/>
              </a:lnSpc>
              <a:spcAft>
                <a:spcPts val="1426"/>
              </a:spcAft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D6EC920-134B-48BA-A99B-BAF2F59D8CA0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502920" y="301680"/>
            <a:ext cx="9064440" cy="12556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4000"/>
              </a:lnSpc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502920" y="1768320"/>
            <a:ext cx="9064440" cy="43783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marL="343080" indent="0" algn="ctr">
              <a:lnSpc>
                <a:spcPct val="94000"/>
              </a:lnSpc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E4E1308-30A5-404F-BEE9-98559D12E239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502920" y="301680"/>
            <a:ext cx="9064440" cy="12556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4000"/>
              </a:lnSpc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502920" y="1768320"/>
            <a:ext cx="9064440" cy="4378320"/>
          </a:xfrm>
          <a:prstGeom prst="rect">
            <a:avLst/>
          </a:prstGeom>
          <a:noFill/>
          <a:ln w="0">
            <a:noFill/>
          </a:ln>
        </p:spPr>
        <p:txBody>
          <a:bodyPr lIns="0" rIns="0" tIns="24120" bIns="0" anchor="t">
            <a:normAutofit/>
          </a:bodyPr>
          <a:p>
            <a:pPr marL="343080" indent="0">
              <a:lnSpc>
                <a:spcPct val="94000"/>
              </a:lnSpc>
              <a:spcAft>
                <a:spcPts val="1426"/>
              </a:spcAft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0C2F4C1-87CF-4281-B62B-B8638B4EBFBA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502920" y="301680"/>
            <a:ext cx="9064440" cy="12556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4000"/>
              </a:lnSpc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502920" y="1768320"/>
            <a:ext cx="4423320" cy="4378320"/>
          </a:xfrm>
          <a:prstGeom prst="rect">
            <a:avLst/>
          </a:prstGeom>
          <a:noFill/>
          <a:ln w="0">
            <a:noFill/>
          </a:ln>
        </p:spPr>
        <p:txBody>
          <a:bodyPr lIns="0" rIns="0" tIns="24120" bIns="0" anchor="t">
            <a:normAutofit/>
          </a:bodyPr>
          <a:p>
            <a:pPr marL="343080" indent="0">
              <a:lnSpc>
                <a:spcPct val="94000"/>
              </a:lnSpc>
              <a:spcAft>
                <a:spcPts val="1426"/>
              </a:spcAft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5147640" y="1768320"/>
            <a:ext cx="4423320" cy="4378320"/>
          </a:xfrm>
          <a:prstGeom prst="rect">
            <a:avLst/>
          </a:prstGeom>
          <a:noFill/>
          <a:ln w="0">
            <a:noFill/>
          </a:ln>
        </p:spPr>
        <p:txBody>
          <a:bodyPr lIns="0" rIns="0" tIns="24120" bIns="0" anchor="t">
            <a:normAutofit/>
          </a:bodyPr>
          <a:p>
            <a:pPr marL="343080" indent="0">
              <a:lnSpc>
                <a:spcPct val="94000"/>
              </a:lnSpc>
              <a:spcAft>
                <a:spcPts val="1426"/>
              </a:spcAft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E44EDA4-9182-4EFB-860E-DBD588679343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502920" y="301680"/>
            <a:ext cx="9064440" cy="12556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4000"/>
              </a:lnSpc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E665369-BA04-4D78-9094-0D71470C37D4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502920" y="301680"/>
            <a:ext cx="9064440" cy="5821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marL="343080" indent="-343080" algn="ctr">
              <a:lnSpc>
                <a:spcPct val="94000"/>
              </a:lnSpc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8CE8AE9-9D2E-4596-9C83-328BD66F4D0D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502920" y="301680"/>
            <a:ext cx="9064440" cy="12556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4000"/>
              </a:lnSpc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502920" y="1768320"/>
            <a:ext cx="4423320" cy="2088360"/>
          </a:xfrm>
          <a:prstGeom prst="rect">
            <a:avLst/>
          </a:prstGeom>
          <a:noFill/>
          <a:ln w="0">
            <a:noFill/>
          </a:ln>
        </p:spPr>
        <p:txBody>
          <a:bodyPr lIns="0" rIns="0" tIns="24120" bIns="0" anchor="t">
            <a:normAutofit/>
          </a:bodyPr>
          <a:p>
            <a:pPr marL="343080" indent="0">
              <a:lnSpc>
                <a:spcPct val="94000"/>
              </a:lnSpc>
              <a:spcAft>
                <a:spcPts val="1426"/>
              </a:spcAft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5147640" y="1768320"/>
            <a:ext cx="4423320" cy="4378320"/>
          </a:xfrm>
          <a:prstGeom prst="rect">
            <a:avLst/>
          </a:prstGeom>
          <a:noFill/>
          <a:ln w="0">
            <a:noFill/>
          </a:ln>
        </p:spPr>
        <p:txBody>
          <a:bodyPr lIns="0" rIns="0" tIns="24120" bIns="0" anchor="t">
            <a:normAutofit/>
          </a:bodyPr>
          <a:p>
            <a:pPr marL="343080" indent="0">
              <a:lnSpc>
                <a:spcPct val="94000"/>
              </a:lnSpc>
              <a:spcAft>
                <a:spcPts val="1426"/>
              </a:spcAft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502920" y="4055400"/>
            <a:ext cx="4423320" cy="2088360"/>
          </a:xfrm>
          <a:prstGeom prst="rect">
            <a:avLst/>
          </a:prstGeom>
          <a:noFill/>
          <a:ln w="0">
            <a:noFill/>
          </a:ln>
        </p:spPr>
        <p:txBody>
          <a:bodyPr lIns="0" rIns="0" tIns="24120" bIns="0" anchor="t">
            <a:normAutofit/>
          </a:bodyPr>
          <a:p>
            <a:pPr marL="343080" indent="0">
              <a:lnSpc>
                <a:spcPct val="94000"/>
              </a:lnSpc>
              <a:spcAft>
                <a:spcPts val="1426"/>
              </a:spcAft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5E262F9-43A6-4DFC-8857-B47616F2E13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502920" y="301680"/>
            <a:ext cx="9064440" cy="12556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4000"/>
              </a:lnSpc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502920" y="1768320"/>
            <a:ext cx="4423320" cy="4378320"/>
          </a:xfrm>
          <a:prstGeom prst="rect">
            <a:avLst/>
          </a:prstGeom>
          <a:noFill/>
          <a:ln w="0">
            <a:noFill/>
          </a:ln>
        </p:spPr>
        <p:txBody>
          <a:bodyPr lIns="0" rIns="0" tIns="24120" bIns="0" anchor="t">
            <a:normAutofit/>
          </a:bodyPr>
          <a:p>
            <a:pPr marL="343080" indent="0">
              <a:lnSpc>
                <a:spcPct val="94000"/>
              </a:lnSpc>
              <a:spcAft>
                <a:spcPts val="1426"/>
              </a:spcAft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5147640" y="1768320"/>
            <a:ext cx="4423320" cy="2088360"/>
          </a:xfrm>
          <a:prstGeom prst="rect">
            <a:avLst/>
          </a:prstGeom>
          <a:noFill/>
          <a:ln w="0">
            <a:noFill/>
          </a:ln>
        </p:spPr>
        <p:txBody>
          <a:bodyPr lIns="0" rIns="0" tIns="24120" bIns="0" anchor="t">
            <a:normAutofit/>
          </a:bodyPr>
          <a:p>
            <a:pPr marL="343080" indent="0">
              <a:lnSpc>
                <a:spcPct val="94000"/>
              </a:lnSpc>
              <a:spcAft>
                <a:spcPts val="1426"/>
              </a:spcAft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5147640" y="4055400"/>
            <a:ext cx="4423320" cy="2088360"/>
          </a:xfrm>
          <a:prstGeom prst="rect">
            <a:avLst/>
          </a:prstGeom>
          <a:noFill/>
          <a:ln w="0">
            <a:noFill/>
          </a:ln>
        </p:spPr>
        <p:txBody>
          <a:bodyPr lIns="0" rIns="0" tIns="24120" bIns="0" anchor="t">
            <a:normAutofit/>
          </a:bodyPr>
          <a:p>
            <a:pPr marL="343080" indent="0">
              <a:lnSpc>
                <a:spcPct val="94000"/>
              </a:lnSpc>
              <a:spcAft>
                <a:spcPts val="1426"/>
              </a:spcAft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5EB66F5-1995-4E92-9403-67A96523329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502920" y="301680"/>
            <a:ext cx="9064440" cy="12556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4000"/>
              </a:lnSpc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502920" y="1768320"/>
            <a:ext cx="4423320" cy="2088360"/>
          </a:xfrm>
          <a:prstGeom prst="rect">
            <a:avLst/>
          </a:prstGeom>
          <a:noFill/>
          <a:ln w="0">
            <a:noFill/>
          </a:ln>
        </p:spPr>
        <p:txBody>
          <a:bodyPr lIns="0" rIns="0" tIns="24120" bIns="0" anchor="t">
            <a:normAutofit/>
          </a:bodyPr>
          <a:p>
            <a:pPr marL="343080" indent="0">
              <a:lnSpc>
                <a:spcPct val="94000"/>
              </a:lnSpc>
              <a:spcAft>
                <a:spcPts val="1426"/>
              </a:spcAft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5147640" y="1768320"/>
            <a:ext cx="4423320" cy="2088360"/>
          </a:xfrm>
          <a:prstGeom prst="rect">
            <a:avLst/>
          </a:prstGeom>
          <a:noFill/>
          <a:ln w="0">
            <a:noFill/>
          </a:ln>
        </p:spPr>
        <p:txBody>
          <a:bodyPr lIns="0" rIns="0" tIns="24120" bIns="0" anchor="t">
            <a:normAutofit/>
          </a:bodyPr>
          <a:p>
            <a:pPr marL="343080" indent="0">
              <a:lnSpc>
                <a:spcPct val="94000"/>
              </a:lnSpc>
              <a:spcAft>
                <a:spcPts val="1426"/>
              </a:spcAft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502920" y="4055400"/>
            <a:ext cx="9064440" cy="2088360"/>
          </a:xfrm>
          <a:prstGeom prst="rect">
            <a:avLst/>
          </a:prstGeom>
          <a:noFill/>
          <a:ln w="0">
            <a:noFill/>
          </a:ln>
        </p:spPr>
        <p:txBody>
          <a:bodyPr lIns="0" rIns="0" tIns="24120" bIns="0" anchor="t">
            <a:normAutofit/>
          </a:bodyPr>
          <a:p>
            <a:pPr marL="343080" indent="0">
              <a:lnSpc>
                <a:spcPct val="94000"/>
              </a:lnSpc>
              <a:spcAft>
                <a:spcPts val="1426"/>
              </a:spcAft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32BC035-617C-49E6-8FD8-EB323D24499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502920" y="301680"/>
            <a:ext cx="9064440" cy="12556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4000"/>
              </a:lnSpc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502920" y="1768320"/>
            <a:ext cx="9064440" cy="4378320"/>
          </a:xfrm>
          <a:prstGeom prst="rect">
            <a:avLst/>
          </a:prstGeom>
          <a:noFill/>
          <a:ln w="0">
            <a:noFill/>
          </a:ln>
        </p:spPr>
        <p:txBody>
          <a:bodyPr lIns="0" rIns="0" tIns="24120" bIns="0" anchor="t">
            <a:normAutofit/>
          </a:bodyPr>
          <a:p>
            <a:pPr marL="343080" indent="0">
              <a:lnSpc>
                <a:spcPct val="94000"/>
              </a:lnSpc>
              <a:spcAft>
                <a:spcPts val="1426"/>
              </a:spcAft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343080" indent="-343080">
              <a:lnSpc>
                <a:spcPct val="94000"/>
              </a:lnSpc>
              <a:spcAft>
                <a:spcPts val="1426"/>
              </a:spcAft>
              <a:buClr>
                <a:srgbClr val="000000"/>
              </a:buClr>
              <a:buFont typeface="Times New Roman"/>
              <a:buChar char="–"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343080" indent="-343080">
              <a:lnSpc>
                <a:spcPct val="94000"/>
              </a:lnSpc>
              <a:spcAft>
                <a:spcPts val="1426"/>
              </a:spcAft>
              <a:buClr>
                <a:srgbClr val="000000"/>
              </a:buClr>
              <a:buFont typeface="Times New Roman"/>
              <a:buChar char="•"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343080" indent="-343080">
              <a:lnSpc>
                <a:spcPct val="94000"/>
              </a:lnSpc>
              <a:spcAft>
                <a:spcPts val="1426"/>
              </a:spcAft>
              <a:buClr>
                <a:srgbClr val="000000"/>
              </a:buClr>
              <a:buFont typeface="Times New Roman"/>
              <a:buChar char="–"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343080" indent="-343080">
              <a:lnSpc>
                <a:spcPct val="94000"/>
              </a:lnSpc>
              <a:spcAft>
                <a:spcPts val="1426"/>
              </a:spcAft>
              <a:buClr>
                <a:srgbClr val="000000"/>
              </a:buClr>
              <a:buFont typeface="Times New Roman"/>
              <a:buChar char="»"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343080" indent="-343080">
              <a:lnSpc>
                <a:spcPct val="94000"/>
              </a:lnSpc>
              <a:spcAft>
                <a:spcPts val="1426"/>
              </a:spcAft>
              <a:buClr>
                <a:srgbClr val="000000"/>
              </a:buClr>
              <a:buFont typeface="Times New Roman"/>
              <a:buChar char="»"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343080" indent="-343080">
              <a:lnSpc>
                <a:spcPct val="94000"/>
              </a:lnSpc>
              <a:spcAft>
                <a:spcPts val="1426"/>
              </a:spcAft>
              <a:buClr>
                <a:srgbClr val="000000"/>
              </a:buClr>
              <a:buFont typeface="Times New Roman"/>
              <a:buChar char="»"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503280" y="6886080"/>
            <a:ext cx="2341440" cy="5144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lstStyle>
            <a:lvl1pPr indent="0">
              <a:lnSpc>
                <a:spcPct val="94000"/>
              </a:lnSpc>
              <a:buNone/>
              <a:tabLst>
                <a:tab algn="l" pos="0"/>
                <a:tab algn="l" pos="447840"/>
                <a:tab algn="l" pos="896760"/>
                <a:tab algn="l" pos="1346040"/>
                <a:tab algn="l" pos="1795320"/>
                <a:tab algn="l" pos="2244600"/>
                <a:tab algn="l" pos="2693880"/>
                <a:tab algn="l" pos="3143160"/>
                <a:tab algn="l" pos="3592440"/>
                <a:tab algn="l" pos="4041720"/>
                <a:tab algn="l" pos="4491000"/>
                <a:tab algn="l" pos="4940280"/>
                <a:tab algn="l" pos="5389560"/>
                <a:tab algn="l" pos="5838840"/>
                <a:tab algn="l" pos="6288120"/>
                <a:tab algn="l" pos="6737400"/>
                <a:tab algn="l" pos="7186680"/>
                <a:tab algn="l" pos="7635960"/>
                <a:tab algn="l" pos="8085240"/>
                <a:tab algn="l" pos="8534520"/>
                <a:tab algn="l" pos="8983800"/>
                <a:tab algn="l" pos="8985240"/>
                <a:tab algn="l" pos="9434520"/>
                <a:tab algn="l" pos="9883800"/>
                <a:tab algn="l" pos="10333080"/>
                <a:tab algn="l" pos="10782360"/>
              </a:tabLst>
              <a:defRPr b="0" lang="en-US" sz="18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lnSpc>
                <a:spcPct val="94000"/>
              </a:lnSpc>
              <a:buNone/>
              <a:tabLst>
                <a:tab algn="l" pos="0"/>
                <a:tab algn="l" pos="447840"/>
                <a:tab algn="l" pos="896760"/>
                <a:tab algn="l" pos="1346040"/>
                <a:tab algn="l" pos="1795320"/>
                <a:tab algn="l" pos="2244600"/>
                <a:tab algn="l" pos="2693880"/>
                <a:tab algn="l" pos="3143160"/>
                <a:tab algn="l" pos="3592440"/>
                <a:tab algn="l" pos="4041720"/>
                <a:tab algn="l" pos="4491000"/>
                <a:tab algn="l" pos="4940280"/>
                <a:tab algn="l" pos="5389560"/>
                <a:tab algn="l" pos="5838840"/>
                <a:tab algn="l" pos="6288120"/>
                <a:tab algn="l" pos="6737400"/>
                <a:tab algn="l" pos="7186680"/>
                <a:tab algn="l" pos="7635960"/>
                <a:tab algn="l" pos="8085240"/>
                <a:tab algn="l" pos="8534520"/>
                <a:tab algn="l" pos="8983800"/>
                <a:tab algn="l" pos="8985240"/>
                <a:tab algn="l" pos="9434520"/>
                <a:tab algn="l" pos="9883800"/>
                <a:tab algn="l" pos="10333080"/>
                <a:tab algn="l" pos="1078236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447720" y="6886080"/>
            <a:ext cx="3189240" cy="5144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lstStyle>
            <a:lvl1pPr indent="0">
              <a:lnSpc>
                <a:spcPct val="94000"/>
              </a:lnSpc>
              <a:buNone/>
              <a:tabLst>
                <a:tab algn="l" pos="0"/>
                <a:tab algn="l" pos="447840"/>
                <a:tab algn="l" pos="896760"/>
                <a:tab algn="l" pos="1346040"/>
                <a:tab algn="l" pos="1795320"/>
                <a:tab algn="l" pos="2244600"/>
                <a:tab algn="l" pos="2693880"/>
                <a:tab algn="l" pos="3143160"/>
                <a:tab algn="l" pos="3592440"/>
                <a:tab algn="l" pos="4041720"/>
                <a:tab algn="l" pos="4491000"/>
                <a:tab algn="l" pos="4940280"/>
                <a:tab algn="l" pos="5389560"/>
                <a:tab algn="l" pos="5838840"/>
                <a:tab algn="l" pos="6288120"/>
                <a:tab algn="l" pos="6737400"/>
                <a:tab algn="l" pos="7186680"/>
                <a:tab algn="l" pos="7635960"/>
                <a:tab algn="l" pos="8085240"/>
                <a:tab algn="l" pos="8534520"/>
                <a:tab algn="l" pos="8983800"/>
                <a:tab algn="l" pos="8985240"/>
                <a:tab algn="l" pos="9434520"/>
                <a:tab algn="l" pos="9883800"/>
                <a:tab algn="l" pos="10333080"/>
                <a:tab algn="l" pos="10782360"/>
              </a:tabLst>
              <a:defRPr b="0" lang="en-US" sz="18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lnSpc>
                <a:spcPct val="94000"/>
              </a:lnSpc>
              <a:buNone/>
              <a:tabLst>
                <a:tab algn="l" pos="0"/>
                <a:tab algn="l" pos="447840"/>
                <a:tab algn="l" pos="896760"/>
                <a:tab algn="l" pos="1346040"/>
                <a:tab algn="l" pos="1795320"/>
                <a:tab algn="l" pos="2244600"/>
                <a:tab algn="l" pos="2693880"/>
                <a:tab algn="l" pos="3143160"/>
                <a:tab algn="l" pos="3592440"/>
                <a:tab algn="l" pos="4041720"/>
                <a:tab algn="l" pos="4491000"/>
                <a:tab algn="l" pos="4940280"/>
                <a:tab algn="l" pos="5389560"/>
                <a:tab algn="l" pos="5838840"/>
                <a:tab algn="l" pos="6288120"/>
                <a:tab algn="l" pos="6737400"/>
                <a:tab algn="l" pos="7186680"/>
                <a:tab algn="l" pos="7635960"/>
                <a:tab algn="l" pos="8085240"/>
                <a:tab algn="l" pos="8534520"/>
                <a:tab algn="l" pos="8983800"/>
                <a:tab algn="l" pos="8985240"/>
                <a:tab algn="l" pos="9434520"/>
                <a:tab algn="l" pos="9883800"/>
                <a:tab algn="l" pos="10333080"/>
                <a:tab algn="l" pos="1078236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7227360" y="6886080"/>
            <a:ext cx="2341800" cy="5144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lstStyle>
            <a:lvl1pPr indent="0">
              <a:lnSpc>
                <a:spcPct val="94000"/>
              </a:lnSpc>
              <a:buNone/>
              <a:tabLst>
                <a:tab algn="l" pos="0"/>
                <a:tab algn="l" pos="447840"/>
                <a:tab algn="l" pos="896760"/>
                <a:tab algn="l" pos="1346040"/>
                <a:tab algn="l" pos="1795320"/>
                <a:tab algn="l" pos="2244600"/>
                <a:tab algn="l" pos="2693880"/>
                <a:tab algn="l" pos="3143160"/>
                <a:tab algn="l" pos="3592440"/>
                <a:tab algn="l" pos="4041720"/>
                <a:tab algn="l" pos="4491000"/>
                <a:tab algn="l" pos="4940280"/>
                <a:tab algn="l" pos="5389560"/>
                <a:tab algn="l" pos="5838840"/>
                <a:tab algn="l" pos="6288120"/>
                <a:tab algn="l" pos="6737400"/>
                <a:tab algn="l" pos="7186680"/>
                <a:tab algn="l" pos="7635960"/>
                <a:tab algn="l" pos="8085240"/>
                <a:tab algn="l" pos="8534520"/>
                <a:tab algn="l" pos="8983800"/>
                <a:tab algn="l" pos="8985240"/>
                <a:tab algn="l" pos="9434520"/>
                <a:tab algn="l" pos="9883800"/>
                <a:tab algn="l" pos="10333080"/>
                <a:tab algn="l" pos="10782360"/>
              </a:tabLst>
              <a:defRPr b="0" lang="en-US" sz="18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lnSpc>
                <a:spcPct val="94000"/>
              </a:lnSpc>
              <a:buNone/>
              <a:tabLst>
                <a:tab algn="l" pos="0"/>
                <a:tab algn="l" pos="447840"/>
                <a:tab algn="l" pos="896760"/>
                <a:tab algn="l" pos="1346040"/>
                <a:tab algn="l" pos="1795320"/>
                <a:tab algn="l" pos="2244600"/>
                <a:tab algn="l" pos="2693880"/>
                <a:tab algn="l" pos="3143160"/>
                <a:tab algn="l" pos="3592440"/>
                <a:tab algn="l" pos="4041720"/>
                <a:tab algn="l" pos="4491000"/>
                <a:tab algn="l" pos="4940280"/>
                <a:tab algn="l" pos="5389560"/>
                <a:tab algn="l" pos="5838840"/>
                <a:tab algn="l" pos="6288120"/>
                <a:tab algn="l" pos="6737400"/>
                <a:tab algn="l" pos="7186680"/>
                <a:tab algn="l" pos="7635960"/>
                <a:tab algn="l" pos="8085240"/>
                <a:tab algn="l" pos="8534520"/>
                <a:tab algn="l" pos="8983800"/>
                <a:tab algn="l" pos="8985240"/>
                <a:tab algn="l" pos="9434520"/>
                <a:tab algn="l" pos="9883800"/>
                <a:tab algn="l" pos="10333080"/>
                <a:tab algn="l" pos="10782360"/>
              </a:tabLst>
            </a:pPr>
            <a:fld id="{949F92AD-1763-49FC-A33C-F913B3ADFCCD}" type="slidenum">
              <a:rPr b="0" lang="en-US" sz="18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slideLayout" Target="../slideLayouts/slideLayout2.xml"/><Relationship Id="rId3" Type="http://schemas.openxmlformats.org/officeDocument/2006/relationships/notesSlide" Target="../notesSlides/notesSlide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2.png"/><Relationship Id="rId2" Type="http://schemas.openxmlformats.org/officeDocument/2006/relationships/slideLayout" Target="../slideLayouts/slideLayout3.xml"/><Relationship Id="rId3" Type="http://schemas.openxmlformats.org/officeDocument/2006/relationships/notesSlide" Target="../notesSlides/notesSlide2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image" Target="../media/image3.png"/><Relationship Id="rId2" Type="http://schemas.openxmlformats.org/officeDocument/2006/relationships/slideLayout" Target="../slideLayouts/slideLayout3.xml"/><Relationship Id="rId3" Type="http://schemas.openxmlformats.org/officeDocument/2006/relationships/notesSlide" Target="../notesSlides/notesSlide3.xml"/>
</Relationships>
</file>

<file path=ppt/slides/_rels/slide4.xml.rels><?xml version="1.0" encoding="UTF-8"?>
<Relationships xmlns="http://schemas.openxmlformats.org/package/2006/relationships"><Relationship Id="rId1" Type="http://schemas.openxmlformats.org/officeDocument/2006/relationships/image" Target="../media/image4.png"/><Relationship Id="rId2" Type="http://schemas.openxmlformats.org/officeDocument/2006/relationships/slideLayout" Target="../slideLayouts/slideLayout3.xml"/><Relationship Id="rId3" Type="http://schemas.openxmlformats.org/officeDocument/2006/relationships/notesSlide" Target="../notesSlides/notesSlide4.xml"/>
</Relationships>
</file>

<file path=ppt/slides/_rels/slide5.xml.rels><?xml version="1.0" encoding="UTF-8"?>
<Relationships xmlns="http://schemas.openxmlformats.org/package/2006/relationships"><Relationship Id="rId1" Type="http://schemas.openxmlformats.org/officeDocument/2006/relationships/image" Target="../media/image5.png"/><Relationship Id="rId2" Type="http://schemas.openxmlformats.org/officeDocument/2006/relationships/slideLayout" Target="../slideLayouts/slideLayout3.xml"/><Relationship Id="rId3" Type="http://schemas.openxmlformats.org/officeDocument/2006/relationships/notesSlide" Target="../notesSlides/notesSlide5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1" name="" descr=""/>
          <p:cNvPicPr/>
          <p:nvPr/>
        </p:nvPicPr>
        <p:blipFill>
          <a:blip r:embed="rId1"/>
          <a:stretch/>
        </p:blipFill>
        <p:spPr>
          <a:xfrm>
            <a:off x="2689200" y="453960"/>
            <a:ext cx="6858000" cy="6858000"/>
          </a:xfrm>
          <a:prstGeom prst="rect">
            <a:avLst/>
          </a:prstGeom>
          <a:ln w="0">
            <a:noFill/>
          </a:ln>
        </p:spPr>
      </p:pic>
      <p:sp>
        <p:nvSpPr>
          <p:cNvPr id="52" name=""/>
          <p:cNvSpPr/>
          <p:nvPr/>
        </p:nvSpPr>
        <p:spPr>
          <a:xfrm>
            <a:off x="2743200" y="4267080"/>
            <a:ext cx="6765840" cy="182520"/>
          </a:xfrm>
          <a:prstGeom prst="rect">
            <a:avLst/>
          </a:prstGeom>
          <a:noFill/>
          <a:ln w="9360">
            <a:solidFill>
              <a:srgbClr val="3465a4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94000"/>
              </a:lnSpc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"/>
          <p:cNvSpPr/>
          <p:nvPr/>
        </p:nvSpPr>
        <p:spPr>
          <a:xfrm>
            <a:off x="2743200" y="2792520"/>
            <a:ext cx="6765840" cy="182520"/>
          </a:xfrm>
          <a:prstGeom prst="rect">
            <a:avLst/>
          </a:prstGeom>
          <a:noFill/>
          <a:ln w="9360">
            <a:solidFill>
              <a:srgbClr val="3465a4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94000"/>
              </a:lnSpc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"/>
          <p:cNvSpPr/>
          <p:nvPr/>
        </p:nvSpPr>
        <p:spPr>
          <a:xfrm rot="5400000">
            <a:off x="1422720" y="3799440"/>
            <a:ext cx="6765840" cy="182520"/>
          </a:xfrm>
          <a:prstGeom prst="rect">
            <a:avLst/>
          </a:prstGeom>
          <a:noFill/>
          <a:ln w="9360">
            <a:solidFill>
              <a:srgbClr val="3465a4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94000"/>
              </a:lnSpc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"/>
          <p:cNvSpPr/>
          <p:nvPr/>
        </p:nvSpPr>
        <p:spPr>
          <a:xfrm rot="5400000">
            <a:off x="2899080" y="3799440"/>
            <a:ext cx="6765840" cy="182520"/>
          </a:xfrm>
          <a:prstGeom prst="rect">
            <a:avLst/>
          </a:prstGeom>
          <a:noFill/>
          <a:ln w="9360">
            <a:solidFill>
              <a:srgbClr val="3465a4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94000"/>
              </a:lnSpc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"/>
          <p:cNvSpPr/>
          <p:nvPr/>
        </p:nvSpPr>
        <p:spPr>
          <a:xfrm>
            <a:off x="181080" y="2863800"/>
            <a:ext cx="2508120" cy="1170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58680" bIns="45000" anchor="t">
            <a:noAutofit/>
          </a:bodyPr>
          <a:p>
            <a:pPr>
              <a:lnSpc>
                <a:spcPct val="94000"/>
              </a:lnSpc>
              <a:tabLst>
                <a:tab algn="l" pos="0"/>
                <a:tab algn="l" pos="447840"/>
                <a:tab algn="l" pos="896760"/>
                <a:tab algn="l" pos="1346040"/>
                <a:tab algn="l" pos="1795320"/>
                <a:tab algn="l" pos="2244600"/>
                <a:tab algn="l" pos="2693880"/>
                <a:tab algn="l" pos="3143160"/>
                <a:tab algn="l" pos="3592440"/>
                <a:tab algn="l" pos="4041720"/>
                <a:tab algn="l" pos="4491000"/>
                <a:tab algn="l" pos="4940280"/>
                <a:tab algn="l" pos="5389560"/>
                <a:tab algn="l" pos="5838840"/>
                <a:tab algn="l" pos="6288120"/>
                <a:tab algn="l" pos="6737400"/>
                <a:tab algn="l" pos="7186680"/>
                <a:tab algn="l" pos="7635960"/>
                <a:tab algn="l" pos="8085240"/>
                <a:tab algn="l" pos="8534520"/>
                <a:tab algn="l" pos="8983800"/>
                <a:tab algn="l" pos="8985240"/>
                <a:tab algn="l" pos="9434520"/>
                <a:tab algn="l" pos="9883800"/>
                <a:tab algn="l" pos="10333080"/>
                <a:tab algn="l" pos="1078236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Linkage Disequilibrium on Significant Regions of Chromosome 1H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7" name="" descr=""/>
          <p:cNvPicPr/>
          <p:nvPr/>
        </p:nvPicPr>
        <p:blipFill>
          <a:blip r:embed="rId1"/>
          <a:stretch/>
        </p:blipFill>
        <p:spPr>
          <a:xfrm>
            <a:off x="2438280" y="-6480"/>
            <a:ext cx="7559640" cy="7559640"/>
          </a:xfrm>
          <a:prstGeom prst="rect">
            <a:avLst/>
          </a:prstGeom>
          <a:ln w="0">
            <a:noFill/>
          </a:ln>
        </p:spPr>
      </p:pic>
      <p:sp>
        <p:nvSpPr>
          <p:cNvPr id="58" name=""/>
          <p:cNvSpPr/>
          <p:nvPr/>
        </p:nvSpPr>
        <p:spPr>
          <a:xfrm>
            <a:off x="2487600" y="4370400"/>
            <a:ext cx="7407360" cy="68400"/>
          </a:xfrm>
          <a:prstGeom prst="rect">
            <a:avLst/>
          </a:prstGeom>
          <a:noFill/>
          <a:ln w="9360">
            <a:solidFill>
              <a:srgbClr val="3465a4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1600" bIns="21600" anchor="ctr">
            <a:noAutofit/>
          </a:bodyPr>
          <a:p>
            <a:pPr>
              <a:lnSpc>
                <a:spcPct val="94000"/>
              </a:lnSpc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"/>
          <p:cNvSpPr/>
          <p:nvPr/>
        </p:nvSpPr>
        <p:spPr>
          <a:xfrm>
            <a:off x="2487600" y="2174760"/>
            <a:ext cx="7407360" cy="68400"/>
          </a:xfrm>
          <a:prstGeom prst="rect">
            <a:avLst/>
          </a:prstGeom>
          <a:noFill/>
          <a:ln w="9360">
            <a:solidFill>
              <a:srgbClr val="3465a4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1600" bIns="21600" anchor="ctr">
            <a:noAutofit/>
          </a:bodyPr>
          <a:p>
            <a:pPr>
              <a:lnSpc>
                <a:spcPct val="94000"/>
              </a:lnSpc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"/>
          <p:cNvSpPr/>
          <p:nvPr/>
        </p:nvSpPr>
        <p:spPr>
          <a:xfrm rot="5400000">
            <a:off x="1324440" y="3723480"/>
            <a:ext cx="7407360" cy="68400"/>
          </a:xfrm>
          <a:prstGeom prst="rect">
            <a:avLst/>
          </a:prstGeom>
          <a:noFill/>
          <a:ln w="9360">
            <a:solidFill>
              <a:srgbClr val="3465a4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1600" bIns="21600" anchor="ctr">
            <a:noAutofit/>
          </a:bodyPr>
          <a:p>
            <a:pPr>
              <a:lnSpc>
                <a:spcPct val="94000"/>
              </a:lnSpc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"/>
          <p:cNvSpPr/>
          <p:nvPr/>
        </p:nvSpPr>
        <p:spPr>
          <a:xfrm rot="5400000">
            <a:off x="3500640" y="3723480"/>
            <a:ext cx="7407360" cy="68040"/>
          </a:xfrm>
          <a:prstGeom prst="rect">
            <a:avLst/>
          </a:prstGeom>
          <a:noFill/>
          <a:ln w="9360">
            <a:solidFill>
              <a:srgbClr val="3465a4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1240" bIns="21240" anchor="ctr">
            <a:noAutofit/>
          </a:bodyPr>
          <a:p>
            <a:pPr>
              <a:lnSpc>
                <a:spcPct val="94000"/>
              </a:lnSpc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"/>
          <p:cNvSpPr/>
          <p:nvPr/>
        </p:nvSpPr>
        <p:spPr>
          <a:xfrm>
            <a:off x="163440" y="2743200"/>
            <a:ext cx="2508480" cy="1170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58680" bIns="45000" anchor="t">
            <a:noAutofit/>
          </a:bodyPr>
          <a:p>
            <a:pPr>
              <a:lnSpc>
                <a:spcPct val="94000"/>
              </a:lnSpc>
              <a:tabLst>
                <a:tab algn="l" pos="0"/>
                <a:tab algn="l" pos="447840"/>
                <a:tab algn="l" pos="896760"/>
                <a:tab algn="l" pos="1346040"/>
                <a:tab algn="l" pos="1795320"/>
                <a:tab algn="l" pos="2244600"/>
                <a:tab algn="l" pos="2693880"/>
                <a:tab algn="l" pos="3143160"/>
                <a:tab algn="l" pos="3592440"/>
                <a:tab algn="l" pos="4041720"/>
                <a:tab algn="l" pos="4491000"/>
                <a:tab algn="l" pos="4940280"/>
                <a:tab algn="l" pos="5389560"/>
                <a:tab algn="l" pos="5838840"/>
                <a:tab algn="l" pos="6288120"/>
                <a:tab algn="l" pos="6737400"/>
                <a:tab algn="l" pos="7186680"/>
                <a:tab algn="l" pos="7635960"/>
                <a:tab algn="l" pos="8085240"/>
                <a:tab algn="l" pos="8534520"/>
                <a:tab algn="l" pos="8983800"/>
                <a:tab algn="l" pos="8985240"/>
                <a:tab algn="l" pos="9434520"/>
                <a:tab algn="l" pos="9883800"/>
                <a:tab algn="l" pos="10333080"/>
                <a:tab algn="l" pos="1078236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Linkage Disequilibrium on Significant Regions of Chromosome 6H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3" name="" descr=""/>
          <p:cNvPicPr/>
          <p:nvPr/>
        </p:nvPicPr>
        <p:blipFill>
          <a:blip r:embed="rId1"/>
          <a:stretch/>
        </p:blipFill>
        <p:spPr>
          <a:xfrm>
            <a:off x="2676600" y="455760"/>
            <a:ext cx="6858000" cy="6858000"/>
          </a:xfrm>
          <a:prstGeom prst="rect">
            <a:avLst/>
          </a:prstGeom>
          <a:ln w="0">
            <a:noFill/>
          </a:ln>
        </p:spPr>
      </p:pic>
      <p:sp>
        <p:nvSpPr>
          <p:cNvPr id="64" name=""/>
          <p:cNvSpPr/>
          <p:nvPr/>
        </p:nvSpPr>
        <p:spPr>
          <a:xfrm>
            <a:off x="163440" y="2743200"/>
            <a:ext cx="2508480" cy="1170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58680" bIns="45000" anchor="t">
            <a:noAutofit/>
          </a:bodyPr>
          <a:p>
            <a:pPr>
              <a:lnSpc>
                <a:spcPct val="94000"/>
              </a:lnSpc>
              <a:tabLst>
                <a:tab algn="l" pos="0"/>
                <a:tab algn="l" pos="447840"/>
                <a:tab algn="l" pos="896760"/>
                <a:tab algn="l" pos="1346040"/>
                <a:tab algn="l" pos="1795320"/>
                <a:tab algn="l" pos="2244600"/>
                <a:tab algn="l" pos="2693880"/>
                <a:tab algn="l" pos="3143160"/>
                <a:tab algn="l" pos="3592440"/>
                <a:tab algn="l" pos="4041720"/>
                <a:tab algn="l" pos="4491000"/>
                <a:tab algn="l" pos="4940280"/>
                <a:tab algn="l" pos="5389560"/>
                <a:tab algn="l" pos="5838840"/>
                <a:tab algn="l" pos="6288120"/>
                <a:tab algn="l" pos="6737400"/>
                <a:tab algn="l" pos="7186680"/>
                <a:tab algn="l" pos="7635960"/>
                <a:tab algn="l" pos="8085240"/>
                <a:tab algn="l" pos="8534520"/>
                <a:tab algn="l" pos="8983800"/>
                <a:tab algn="l" pos="8985240"/>
                <a:tab algn="l" pos="9434520"/>
                <a:tab algn="l" pos="9883800"/>
                <a:tab algn="l" pos="10333080"/>
                <a:tab algn="l" pos="1078236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Linkage Disequilibrium on First Significant Region of Chromosome 7H (7H-A)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"/>
          <p:cNvSpPr/>
          <p:nvPr/>
        </p:nvSpPr>
        <p:spPr>
          <a:xfrm>
            <a:off x="2743200" y="4916520"/>
            <a:ext cx="6765840" cy="182520"/>
          </a:xfrm>
          <a:prstGeom prst="rect">
            <a:avLst/>
          </a:prstGeom>
          <a:noFill/>
          <a:ln w="9360">
            <a:solidFill>
              <a:srgbClr val="3465a4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94000"/>
              </a:lnSpc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" name=""/>
          <p:cNvSpPr/>
          <p:nvPr/>
        </p:nvSpPr>
        <p:spPr>
          <a:xfrm rot="5400000">
            <a:off x="775080" y="3799440"/>
            <a:ext cx="6765840" cy="182520"/>
          </a:xfrm>
          <a:prstGeom prst="rect">
            <a:avLst/>
          </a:prstGeom>
          <a:noFill/>
          <a:ln w="9360">
            <a:solidFill>
              <a:srgbClr val="3465a4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94000"/>
              </a:lnSpc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>
</file>

<file path=ppt/slides/slide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7" name="" descr=""/>
          <p:cNvPicPr/>
          <p:nvPr/>
        </p:nvPicPr>
        <p:blipFill>
          <a:blip r:embed="rId1"/>
          <a:stretch/>
        </p:blipFill>
        <p:spPr>
          <a:xfrm>
            <a:off x="2678040" y="457200"/>
            <a:ext cx="6858000" cy="6858000"/>
          </a:xfrm>
          <a:prstGeom prst="rect">
            <a:avLst/>
          </a:prstGeom>
          <a:ln w="0">
            <a:noFill/>
          </a:ln>
        </p:spPr>
      </p:pic>
      <p:sp>
        <p:nvSpPr>
          <p:cNvPr id="68" name=""/>
          <p:cNvSpPr/>
          <p:nvPr/>
        </p:nvSpPr>
        <p:spPr>
          <a:xfrm>
            <a:off x="146160" y="2751120"/>
            <a:ext cx="2508120" cy="1170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58680" bIns="45000" anchor="t">
            <a:noAutofit/>
          </a:bodyPr>
          <a:p>
            <a:pPr>
              <a:lnSpc>
                <a:spcPct val="94000"/>
              </a:lnSpc>
              <a:tabLst>
                <a:tab algn="l" pos="0"/>
                <a:tab algn="l" pos="447840"/>
                <a:tab algn="l" pos="896760"/>
                <a:tab algn="l" pos="1346040"/>
                <a:tab algn="l" pos="1795320"/>
                <a:tab algn="l" pos="2244600"/>
                <a:tab algn="l" pos="2693880"/>
                <a:tab algn="l" pos="3143160"/>
                <a:tab algn="l" pos="3592440"/>
                <a:tab algn="l" pos="4041720"/>
                <a:tab algn="l" pos="4491000"/>
                <a:tab algn="l" pos="4940280"/>
                <a:tab algn="l" pos="5389560"/>
                <a:tab algn="l" pos="5838840"/>
                <a:tab algn="l" pos="6288120"/>
                <a:tab algn="l" pos="6737400"/>
                <a:tab algn="l" pos="7186680"/>
                <a:tab algn="l" pos="7635960"/>
                <a:tab algn="l" pos="8085240"/>
                <a:tab algn="l" pos="8534520"/>
                <a:tab algn="l" pos="8983800"/>
                <a:tab algn="l" pos="8985240"/>
                <a:tab algn="l" pos="9434520"/>
                <a:tab algn="l" pos="9883800"/>
                <a:tab algn="l" pos="10333080"/>
                <a:tab algn="l" pos="1078236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Linkage Disequilibrium on Second Significant Region of Chromosome 7H (7H-B)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" name=""/>
          <p:cNvSpPr/>
          <p:nvPr/>
        </p:nvSpPr>
        <p:spPr>
          <a:xfrm rot="5400000">
            <a:off x="4308120" y="3794040"/>
            <a:ext cx="6742080" cy="68400"/>
          </a:xfrm>
          <a:prstGeom prst="rect">
            <a:avLst/>
          </a:prstGeom>
          <a:noFill/>
          <a:ln w="9360">
            <a:solidFill>
              <a:srgbClr val="3465a4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1600" bIns="21600" anchor="ctr">
            <a:noAutofit/>
          </a:bodyPr>
          <a:p>
            <a:pPr>
              <a:lnSpc>
                <a:spcPct val="94000"/>
              </a:lnSpc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" name=""/>
          <p:cNvSpPr/>
          <p:nvPr/>
        </p:nvSpPr>
        <p:spPr>
          <a:xfrm>
            <a:off x="2735280" y="1655640"/>
            <a:ext cx="6799320" cy="68400"/>
          </a:xfrm>
          <a:prstGeom prst="rect">
            <a:avLst/>
          </a:prstGeom>
          <a:noFill/>
          <a:ln w="9360">
            <a:solidFill>
              <a:srgbClr val="3465a4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1600" bIns="21600" anchor="ctr">
            <a:noAutofit/>
          </a:bodyPr>
          <a:p>
            <a:pPr>
              <a:lnSpc>
                <a:spcPct val="94000"/>
              </a:lnSpc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" name=""/>
          <p:cNvSpPr/>
          <p:nvPr/>
        </p:nvSpPr>
        <p:spPr>
          <a:xfrm rot="5400000">
            <a:off x="4430160" y="3794040"/>
            <a:ext cx="6742080" cy="68040"/>
          </a:xfrm>
          <a:prstGeom prst="rect">
            <a:avLst/>
          </a:prstGeom>
          <a:noFill/>
          <a:ln w="9360">
            <a:solidFill>
              <a:srgbClr val="3465a4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1240" bIns="21240" anchor="ctr">
            <a:noAutofit/>
          </a:bodyPr>
          <a:p>
            <a:pPr>
              <a:lnSpc>
                <a:spcPct val="94000"/>
              </a:lnSpc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" name=""/>
          <p:cNvSpPr/>
          <p:nvPr/>
        </p:nvSpPr>
        <p:spPr>
          <a:xfrm>
            <a:off x="2735280" y="1541520"/>
            <a:ext cx="6799320" cy="68040"/>
          </a:xfrm>
          <a:prstGeom prst="rect">
            <a:avLst/>
          </a:prstGeom>
          <a:noFill/>
          <a:ln w="9360">
            <a:solidFill>
              <a:srgbClr val="3465a4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21240" bIns="21240" anchor="ctr">
            <a:noAutofit/>
          </a:bodyPr>
          <a:p>
            <a:pPr>
              <a:lnSpc>
                <a:spcPct val="94000"/>
              </a:lnSpc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>
</file>

<file path=ppt/slides/slide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3" name="" descr=""/>
          <p:cNvPicPr/>
          <p:nvPr/>
        </p:nvPicPr>
        <p:blipFill>
          <a:blip r:embed="rId1"/>
          <a:stretch/>
        </p:blipFill>
        <p:spPr>
          <a:xfrm>
            <a:off x="2685960" y="415800"/>
            <a:ext cx="6858000" cy="6858000"/>
          </a:xfrm>
          <a:prstGeom prst="rect">
            <a:avLst/>
          </a:prstGeom>
          <a:ln w="0">
            <a:noFill/>
          </a:ln>
        </p:spPr>
      </p:pic>
      <p:sp>
        <p:nvSpPr>
          <p:cNvPr id="74" name=""/>
          <p:cNvSpPr/>
          <p:nvPr/>
        </p:nvSpPr>
        <p:spPr>
          <a:xfrm>
            <a:off x="146160" y="2751120"/>
            <a:ext cx="2508120" cy="1170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58680" bIns="45000" anchor="t">
            <a:noAutofit/>
          </a:bodyPr>
          <a:p>
            <a:pPr>
              <a:lnSpc>
                <a:spcPct val="94000"/>
              </a:lnSpc>
              <a:tabLst>
                <a:tab algn="l" pos="0"/>
                <a:tab algn="l" pos="447840"/>
                <a:tab algn="l" pos="896760"/>
                <a:tab algn="l" pos="1346040"/>
                <a:tab algn="l" pos="1795320"/>
                <a:tab algn="l" pos="2244600"/>
                <a:tab algn="l" pos="2693880"/>
                <a:tab algn="l" pos="3143160"/>
                <a:tab algn="l" pos="3592440"/>
                <a:tab algn="l" pos="4041720"/>
                <a:tab algn="l" pos="4491000"/>
                <a:tab algn="l" pos="4940280"/>
                <a:tab algn="l" pos="5389560"/>
                <a:tab algn="l" pos="5838840"/>
                <a:tab algn="l" pos="6288120"/>
                <a:tab algn="l" pos="6737400"/>
                <a:tab algn="l" pos="7186680"/>
                <a:tab algn="l" pos="7635960"/>
                <a:tab algn="l" pos="8085240"/>
                <a:tab algn="l" pos="8534520"/>
                <a:tab algn="l" pos="8983800"/>
                <a:tab algn="l" pos="8985240"/>
                <a:tab algn="l" pos="9434520"/>
                <a:tab algn="l" pos="9883800"/>
                <a:tab algn="l" pos="10333080"/>
                <a:tab algn="l" pos="1078236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Linkage Disequilibrium on Third Significant Region of Chromosome 7H (7H-C)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" name=""/>
          <p:cNvSpPr/>
          <p:nvPr/>
        </p:nvSpPr>
        <p:spPr>
          <a:xfrm>
            <a:off x="2752560" y="4883040"/>
            <a:ext cx="6766200" cy="136800"/>
          </a:xfrm>
          <a:prstGeom prst="rect">
            <a:avLst/>
          </a:prstGeom>
          <a:noFill/>
          <a:ln w="9360">
            <a:solidFill>
              <a:srgbClr val="3465a4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94000"/>
              </a:lnSpc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" name=""/>
          <p:cNvSpPr/>
          <p:nvPr/>
        </p:nvSpPr>
        <p:spPr>
          <a:xfrm rot="5400000">
            <a:off x="912240" y="3822480"/>
            <a:ext cx="6765840" cy="136440"/>
          </a:xfrm>
          <a:prstGeom prst="rect">
            <a:avLst/>
          </a:prstGeom>
          <a:noFill/>
          <a:ln w="9360">
            <a:solidFill>
              <a:srgbClr val="3465a4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94000"/>
              </a:lnSpc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" name=""/>
          <p:cNvSpPr/>
          <p:nvPr/>
        </p:nvSpPr>
        <p:spPr>
          <a:xfrm>
            <a:off x="2752560" y="4746600"/>
            <a:ext cx="6766200" cy="136440"/>
          </a:xfrm>
          <a:prstGeom prst="rect">
            <a:avLst/>
          </a:prstGeom>
          <a:noFill/>
          <a:ln w="9360">
            <a:solidFill>
              <a:srgbClr val="3465a4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94000"/>
              </a:lnSpc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8" name=""/>
          <p:cNvSpPr/>
          <p:nvPr/>
        </p:nvSpPr>
        <p:spPr>
          <a:xfrm>
            <a:off x="2743200" y="4489560"/>
            <a:ext cx="6765840" cy="136440"/>
          </a:xfrm>
          <a:prstGeom prst="rect">
            <a:avLst/>
          </a:prstGeom>
          <a:noFill/>
          <a:ln w="9360">
            <a:solidFill>
              <a:srgbClr val="3465a4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94000"/>
              </a:lnSpc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9" name=""/>
          <p:cNvSpPr/>
          <p:nvPr/>
        </p:nvSpPr>
        <p:spPr>
          <a:xfrm>
            <a:off x="2743200" y="4214880"/>
            <a:ext cx="6765840" cy="136440"/>
          </a:xfrm>
          <a:prstGeom prst="rect">
            <a:avLst/>
          </a:prstGeom>
          <a:noFill/>
          <a:ln w="9360">
            <a:solidFill>
              <a:srgbClr val="3465a4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94000"/>
              </a:lnSpc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0" name=""/>
          <p:cNvSpPr/>
          <p:nvPr/>
        </p:nvSpPr>
        <p:spPr>
          <a:xfrm>
            <a:off x="2743200" y="3822840"/>
            <a:ext cx="6765840" cy="136440"/>
          </a:xfrm>
          <a:prstGeom prst="rect">
            <a:avLst/>
          </a:prstGeom>
          <a:noFill/>
          <a:ln w="9360">
            <a:solidFill>
              <a:srgbClr val="3465a4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94000"/>
              </a:lnSpc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1" name=""/>
          <p:cNvSpPr/>
          <p:nvPr/>
        </p:nvSpPr>
        <p:spPr>
          <a:xfrm rot="5400000">
            <a:off x="1042560" y="3825720"/>
            <a:ext cx="6765840" cy="136440"/>
          </a:xfrm>
          <a:prstGeom prst="rect">
            <a:avLst/>
          </a:prstGeom>
          <a:noFill/>
          <a:ln w="9360">
            <a:solidFill>
              <a:srgbClr val="3465a4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94000"/>
              </a:lnSpc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2" name=""/>
          <p:cNvSpPr/>
          <p:nvPr/>
        </p:nvSpPr>
        <p:spPr>
          <a:xfrm rot="5400000">
            <a:off x="1309320" y="3822480"/>
            <a:ext cx="6765840" cy="136440"/>
          </a:xfrm>
          <a:prstGeom prst="rect">
            <a:avLst/>
          </a:prstGeom>
          <a:noFill/>
          <a:ln w="9360">
            <a:solidFill>
              <a:srgbClr val="3465a4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94000"/>
              </a:lnSpc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3" name=""/>
          <p:cNvSpPr/>
          <p:nvPr/>
        </p:nvSpPr>
        <p:spPr>
          <a:xfrm rot="5400000">
            <a:off x="1582200" y="3825720"/>
            <a:ext cx="6765840" cy="136440"/>
          </a:xfrm>
          <a:prstGeom prst="rect">
            <a:avLst/>
          </a:prstGeom>
          <a:noFill/>
          <a:ln w="9360">
            <a:solidFill>
              <a:srgbClr val="3465a4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94000"/>
              </a:lnSpc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4" name=""/>
          <p:cNvSpPr/>
          <p:nvPr/>
        </p:nvSpPr>
        <p:spPr>
          <a:xfrm rot="5400000">
            <a:off x="1985400" y="3825720"/>
            <a:ext cx="6765840" cy="136440"/>
          </a:xfrm>
          <a:prstGeom prst="rect">
            <a:avLst/>
          </a:prstGeom>
          <a:noFill/>
          <a:ln w="9360">
            <a:solidFill>
              <a:srgbClr val="3465a4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94000"/>
              </a:lnSpc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5931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4-12-06T03:09:05Z</dcterms:created>
  <dc:creator/>
  <dc:description/>
  <dc:language>en-US</dc:language>
  <cp:lastModifiedBy/>
  <cp:revision>0</cp:revision>
  <dc:subject/>
  <dc:title/>
</cp:coreProperties>
</file>